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350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0"/>
            <a:ext cx="2416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1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332656"/>
            <a:ext cx="8676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lustering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of genes for GSE30169, together with assigned module color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 descr="E:\Global-file\CAD-pathway\CAD-gene-expression\tissue\GSE30169\filter12000\auto_size30_hight0.25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764704"/>
            <a:ext cx="8011178" cy="547957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0"/>
            <a:ext cx="2416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0" y="332656"/>
            <a:ext cx="8676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lustering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of genes for GSE7965, together with assigned module color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 descr="E:\Global-file\CAD-pathway\CAD-gene-expression\tissue\GSE7965_series_matrix.txt\filter_12000\GSE7965_auto_hight0.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764704"/>
            <a:ext cx="8424813" cy="5762501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0"/>
            <a:ext cx="2416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0" y="332656"/>
            <a:ext cx="8676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lustering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of genes for GSE24335, together with assigned module color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5" name="Picture 3" descr="E:\Global-file\CAD-pathway\CAD-gene-expression\tissue\GSE24335_series_matrix.txt\filter_12000\GSE24335_hight0.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692696"/>
            <a:ext cx="8280920" cy="566408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</TotalTime>
  <Words>45</Words>
  <Application>Microsoft Office PowerPoint</Application>
  <PresentationFormat>全屏显示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gobal</dc:creator>
  <cp:lastModifiedBy>Ma Yunlong</cp:lastModifiedBy>
  <cp:revision>13</cp:revision>
  <dcterms:created xsi:type="dcterms:W3CDTF">2018-02-27T01:37:08Z</dcterms:created>
  <dcterms:modified xsi:type="dcterms:W3CDTF">2019-03-28T14:12:07Z</dcterms:modified>
</cp:coreProperties>
</file>